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2" r:id="rId2"/>
    <p:sldId id="275" r:id="rId3"/>
    <p:sldId id="276" r:id="rId4"/>
    <p:sldId id="269" r:id="rId5"/>
    <p:sldId id="274" r:id="rId6"/>
    <p:sldId id="270" r:id="rId7"/>
    <p:sldId id="281" r:id="rId8"/>
    <p:sldId id="272" r:id="rId9"/>
    <p:sldId id="273" r:id="rId10"/>
    <p:sldId id="294" r:id="rId11"/>
    <p:sldId id="280" r:id="rId12"/>
    <p:sldId id="278" r:id="rId13"/>
    <p:sldId id="279" r:id="rId14"/>
    <p:sldId id="295" r:id="rId15"/>
    <p:sldId id="299" r:id="rId16"/>
    <p:sldId id="293" r:id="rId17"/>
    <p:sldId id="301" r:id="rId18"/>
    <p:sldId id="296" r:id="rId19"/>
    <p:sldId id="291" r:id="rId20"/>
    <p:sldId id="288" r:id="rId21"/>
    <p:sldId id="290" r:id="rId22"/>
    <p:sldId id="289" r:id="rId23"/>
    <p:sldId id="297" r:id="rId24"/>
    <p:sldId id="285" r:id="rId25"/>
    <p:sldId id="284" r:id="rId26"/>
    <p:sldId id="271" r:id="rId27"/>
    <p:sldId id="283" r:id="rId2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EB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150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Relationship Id="rId8" Type="http://schemas.openxmlformats.org/officeDocument/2006/relationships/slide" Target="slides/slide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 Jungjoon" userId="817f10990ce5c728" providerId="LiveId" clId="{353DCF19-EA74-4695-9373-E6946E5577A2}"/>
    <pc:docChg chg="modSld">
      <pc:chgData name="Lee Jungjoon" userId="817f10990ce5c728" providerId="LiveId" clId="{353DCF19-EA74-4695-9373-E6946E5577A2}" dt="2022-12-14T10:10:57.489" v="1" actId="113"/>
      <pc:docMkLst>
        <pc:docMk/>
      </pc:docMkLst>
      <pc:sldChg chg="modSp mod">
        <pc:chgData name="Lee Jungjoon" userId="817f10990ce5c728" providerId="LiveId" clId="{353DCF19-EA74-4695-9373-E6946E5577A2}" dt="2022-12-14T10:10:57.489" v="1" actId="113"/>
        <pc:sldMkLst>
          <pc:docMk/>
          <pc:sldMk cId="2668491809" sldId="302"/>
        </pc:sldMkLst>
        <pc:spChg chg="mod">
          <ac:chgData name="Lee Jungjoon" userId="817f10990ce5c728" providerId="LiveId" clId="{353DCF19-EA74-4695-9373-E6946E5577A2}" dt="2022-12-14T10:10:57.489" v="1" actId="113"/>
          <ac:spMkLst>
            <pc:docMk/>
            <pc:sldMk cId="2668491809" sldId="302"/>
            <ac:spMk id="3" creationId="{B48BC34F-14FE-BA2D-EB16-441349C5BFF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5541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6103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492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5361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3290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2409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1242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454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100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6004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4704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69CF0-9B8C-4896-8EAB-8DA0F799DC42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CA16D-EDC8-441A-A1DD-53BAE40C78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1777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48BC34F-14FE-BA2D-EB16-441349C5BFFE}"/>
              </a:ext>
            </a:extLst>
          </p:cNvPr>
          <p:cNvSpPr txBox="1"/>
          <p:nvPr/>
        </p:nvSpPr>
        <p:spPr>
          <a:xfrm>
            <a:off x="735725" y="2803699"/>
            <a:ext cx="7693572" cy="6631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dditional File 3: Table S2. </a:t>
            </a:r>
            <a:r>
              <a:rPr lang="en-US" altLang="ko-KR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nually validated off-target sites from </a:t>
            </a:r>
            <a:r>
              <a:rPr lang="en-US" altLang="ko-KR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tru</a:t>
            </a:r>
            <a:r>
              <a:rPr lang="en-US" altLang="ko-KR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seq WGS data visualized using IGV.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84918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4B81B7-226E-E918-3790-A67175F2A6AE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Mouse </a:t>
            </a:r>
            <a:r>
              <a:rPr lang="en-US" altLang="ko-KR" sz="3200" i="1" dirty="0"/>
              <a:t>PCSK9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39492404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Pcsk9</a:t>
            </a:r>
            <a:r>
              <a:rPr lang="en-US" altLang="ko-KR" dirty="0"/>
              <a:t> chr5:118330947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7321687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5:118330947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8.58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GGAAACTGAGGCTT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1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171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631318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34.903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34.903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74846" y="134414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27208" y="133122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95D08150-54E4-4F72-BF0F-42A4CBAE19A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59" t="17921" r="26132" b="7336"/>
          <a:stretch/>
        </p:blipFill>
        <p:spPr>
          <a:xfrm>
            <a:off x="2950153" y="1600145"/>
            <a:ext cx="2458609" cy="2970324"/>
          </a:xfrm>
          <a:prstGeom prst="rect">
            <a:avLst/>
          </a:prstGeom>
        </p:spPr>
      </p:pic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82B806A4-C123-4573-A854-2FD96ACA1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8428600"/>
              </p:ext>
            </p:extLst>
          </p:nvPr>
        </p:nvGraphicFramePr>
        <p:xfrm>
          <a:off x="2865845" y="442005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GGAAACTGAGGCTT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67670" y="1498814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>
            <a:extLst>
              <a:ext uri="{FF2B5EF4-FFF2-40B4-BE49-F238E27FC236}">
                <a16:creationId xmlns:a16="http://schemas.microsoft.com/office/drawing/2014/main" id="{C8475D7C-07C7-4E10-8A83-CE97794FDC8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88" t="18249" r="26513" b="27587"/>
          <a:stretch/>
        </p:blipFill>
        <p:spPr>
          <a:xfrm>
            <a:off x="263770" y="1600144"/>
            <a:ext cx="2372874" cy="2970323"/>
          </a:xfrm>
          <a:prstGeom prst="rect">
            <a:avLst/>
          </a:prstGeom>
        </p:spPr>
      </p:pic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613DD7B9-C21D-49DE-8864-D00C2836A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0096431"/>
              </p:ext>
            </p:extLst>
          </p:nvPr>
        </p:nvGraphicFramePr>
        <p:xfrm>
          <a:off x="143490" y="441685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GGAAACTGAGGCTT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2043264" y="1513741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12712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Pcsk9</a:t>
            </a:r>
            <a:r>
              <a:rPr lang="en-US" altLang="ko-KR" dirty="0"/>
              <a:t> chr14:70002438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8467698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4:7000243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.582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1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2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2927481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9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1.527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1.527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509350" y="1370022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53087" y="1374361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FE909099-F073-409E-8418-4033C4F742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82" t="17916" r="26401" b="12761"/>
          <a:stretch/>
        </p:blipFill>
        <p:spPr>
          <a:xfrm>
            <a:off x="2980625" y="1592175"/>
            <a:ext cx="2406713" cy="2953506"/>
          </a:xfrm>
          <a:prstGeom prst="rect">
            <a:avLst/>
          </a:prstGeom>
        </p:spPr>
      </p:pic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031DD6C5-015C-4B83-B0A0-9FEEA64935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7722278"/>
              </p:ext>
            </p:extLst>
          </p:nvPr>
        </p:nvGraphicFramePr>
        <p:xfrm>
          <a:off x="2856379" y="446509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67670" y="150744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그림 9">
            <a:extLst>
              <a:ext uri="{FF2B5EF4-FFF2-40B4-BE49-F238E27FC236}">
                <a16:creationId xmlns:a16="http://schemas.microsoft.com/office/drawing/2014/main" id="{249BAFB7-E30E-49EB-A1B9-5A67F81F0D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53" t="24286" r="16731" b="8407"/>
          <a:stretch/>
        </p:blipFill>
        <p:spPr>
          <a:xfrm>
            <a:off x="249508" y="1600140"/>
            <a:ext cx="2406713" cy="2998308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3273360"/>
              </p:ext>
            </p:extLst>
          </p:nvPr>
        </p:nvGraphicFramePr>
        <p:xfrm>
          <a:off x="126238" y="445332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2034638" y="152236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43966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Pcsk9</a:t>
            </a:r>
            <a:r>
              <a:rPr lang="en-US" altLang="ko-KR" dirty="0"/>
              <a:t> chr17:47283184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8890685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7:47283184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.141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AAACTGAGGC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1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7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3201058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8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1.86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1.86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74846" y="134414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18582" y="133985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D675739-7D23-46DA-9BFF-025319DEE8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25" t="17285" r="23765" b="5876"/>
          <a:stretch/>
        </p:blipFill>
        <p:spPr>
          <a:xfrm>
            <a:off x="2952295" y="1585564"/>
            <a:ext cx="2406713" cy="2976278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5888EEFC-6F64-4832-8BD6-FE9D0B75E8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9479265"/>
              </p:ext>
            </p:extLst>
          </p:nvPr>
        </p:nvGraphicFramePr>
        <p:xfrm>
          <a:off x="2839162" y="446448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AAACTGAG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33166" y="1498814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그림 6">
            <a:extLst>
              <a:ext uri="{FF2B5EF4-FFF2-40B4-BE49-F238E27FC236}">
                <a16:creationId xmlns:a16="http://schemas.microsoft.com/office/drawing/2014/main" id="{6F2B858C-D035-477D-AB79-B60A185C46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34" t="15743" r="23744"/>
          <a:stretch/>
        </p:blipFill>
        <p:spPr>
          <a:xfrm>
            <a:off x="263769" y="1594190"/>
            <a:ext cx="2422788" cy="2976278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2548530"/>
              </p:ext>
            </p:extLst>
          </p:nvPr>
        </p:nvGraphicFramePr>
        <p:xfrm>
          <a:off x="126238" y="4453325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AAACTGAG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2034638" y="152236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613DD7B9-C21D-49DE-8864-D00C2836A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3242262"/>
              </p:ext>
            </p:extLst>
          </p:nvPr>
        </p:nvGraphicFramePr>
        <p:xfrm>
          <a:off x="126238" y="445332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AAACTGAG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95913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4B81B7-226E-E918-3790-A67175F2A6AE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Mouse </a:t>
            </a:r>
            <a:r>
              <a:rPr lang="en-US" altLang="ko-KR" sz="3200" i="1" dirty="0"/>
              <a:t>Albumin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24756977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284FED7B-653B-0547-9C0B-327D8549ED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83" t="17772" r="15300" b="11982"/>
          <a:stretch/>
        </p:blipFill>
        <p:spPr>
          <a:xfrm>
            <a:off x="3045126" y="1625804"/>
            <a:ext cx="2304720" cy="292031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3D939675-6A92-566E-D829-FB0230393CA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20" t="18896" r="15198" b="18319"/>
          <a:stretch/>
        </p:blipFill>
        <p:spPr>
          <a:xfrm>
            <a:off x="270291" y="1627017"/>
            <a:ext cx="2381884" cy="27898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Albumin</a:t>
            </a:r>
            <a:r>
              <a:rPr lang="en-US" altLang="ko-KR" dirty="0"/>
              <a:t> </a:t>
            </a:r>
            <a:r>
              <a:rPr lang="en-US" altLang="ko-KR" dirty="0">
                <a:solidFill>
                  <a:srgbClr val="000000"/>
                </a:solidFill>
                <a:ea typeface="맑은 고딕" panose="020B0503020000020004" pitchFamily="50" charset="-127"/>
              </a:rPr>
              <a:t>chr8:84270916</a:t>
            </a:r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3226675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000000"/>
                          </a:solidFill>
                          <a:ea typeface="+mn-ea"/>
                        </a:rPr>
                        <a:t>chr8:84270916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166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ATGTATGTGTG</a:t>
                      </a:r>
                      <a:r>
                        <a:rPr lang="en-US" altLang="ko-KR" sz="11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8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5293128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121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26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95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23090" y="134414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684078" y="133985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82B806A4-C123-4573-A854-2FD96ACA1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2906028"/>
              </p:ext>
            </p:extLst>
          </p:nvPr>
        </p:nvGraphicFramePr>
        <p:xfrm>
          <a:off x="2865845" y="442005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ATGTATG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15914" y="1516066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613DD7B9-C21D-49DE-8864-D00C2836A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9980248"/>
              </p:ext>
            </p:extLst>
          </p:nvPr>
        </p:nvGraphicFramePr>
        <p:xfrm>
          <a:off x="143490" y="441685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ATGTATG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1991508" y="1513741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71485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160B9570-190C-6CC6-7737-2BA4411A6D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94" t="24159" r="12193" b="14686"/>
          <a:stretch/>
        </p:blipFill>
        <p:spPr>
          <a:xfrm>
            <a:off x="3011140" y="1635276"/>
            <a:ext cx="2381883" cy="2956919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D384943F-91E9-F536-00AF-2F37F1ABFC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04" t="23826" r="12437" b="6899"/>
          <a:stretch/>
        </p:blipFill>
        <p:spPr>
          <a:xfrm>
            <a:off x="255143" y="1600759"/>
            <a:ext cx="2381883" cy="29569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Albumin</a:t>
            </a:r>
            <a:r>
              <a:rPr lang="en-US" altLang="ko-KR" dirty="0"/>
              <a:t> </a:t>
            </a:r>
            <a:r>
              <a:rPr lang="en-US" altLang="ko-KR" dirty="0">
                <a:solidFill>
                  <a:srgbClr val="000000"/>
                </a:solidFill>
                <a:ea typeface="맑은 고딕" panose="020B0503020000020004" pitchFamily="50" charset="-127"/>
              </a:rPr>
              <a:t>c</a:t>
            </a:r>
            <a:r>
              <a:rPr lang="en-US" altLang="ko-KR" sz="1800" b="0" i="0" u="none" strike="noStrike" dirty="0">
                <a:solidFill>
                  <a:srgbClr val="000000"/>
                </a:solidFill>
                <a:effectLst/>
                <a:ea typeface="맑은 고딕" panose="020B0503020000020004" pitchFamily="50" charset="-127"/>
              </a:rPr>
              <a:t>hr10:107874854</a:t>
            </a:r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1104694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000000"/>
                          </a:solidFill>
                          <a:ea typeface="+mn-ea"/>
                        </a:rPr>
                        <a:t>c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ea typeface="+mn-ea"/>
                        </a:rPr>
                        <a:t>hr10:107874854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.85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ATG</a:t>
                      </a:r>
                      <a:r>
                        <a:rPr lang="en-US" altLang="ko-KR" sz="1100" u="none" strike="noStrike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GTAT</a:t>
                      </a:r>
                      <a:r>
                        <a:rPr lang="en-US" altLang="ko-KR" sz="1100" u="none" strike="noStrike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100" u="none" strike="noStrike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76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0027066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-3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-2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-1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+1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+2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>
                          <a:latin typeface="+mn-lt"/>
                        </a:rPr>
                        <a:t>+3</a:t>
                      </a:r>
                      <a:endParaRPr lang="ko-KR" altLang="en-US" sz="700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3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3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3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3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3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3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23090" y="134414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684078" y="133985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82B806A4-C123-4573-A854-2FD96ACA1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2719353"/>
              </p:ext>
            </p:extLst>
          </p:nvPr>
        </p:nvGraphicFramePr>
        <p:xfrm>
          <a:off x="2865845" y="442005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ATG</a:t>
                      </a:r>
                      <a:r>
                        <a:rPr lang="en-US" altLang="ko-KR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GTAT</a:t>
                      </a:r>
                      <a:r>
                        <a:rPr lang="en-US" altLang="ko-KR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33166" y="1541944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613DD7B9-C21D-49DE-8864-D00C2836A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7751358"/>
              </p:ext>
            </p:extLst>
          </p:nvPr>
        </p:nvGraphicFramePr>
        <p:xfrm>
          <a:off x="143490" y="441685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ATG</a:t>
                      </a:r>
                      <a:r>
                        <a:rPr lang="en-US" altLang="ko-KR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GTAT</a:t>
                      </a:r>
                      <a:r>
                        <a:rPr lang="en-US" altLang="ko-KR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1991508" y="1513741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19886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94E31797-1942-0DD6-B0F3-320727A194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86" t="18601" r="17451" b="14470"/>
          <a:stretch/>
        </p:blipFill>
        <p:spPr>
          <a:xfrm>
            <a:off x="355602" y="1629307"/>
            <a:ext cx="2275613" cy="2973926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827FADC6-F458-7B6D-ED03-61CE359E15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61" t="18553" r="17334" b="12576"/>
          <a:stretch/>
        </p:blipFill>
        <p:spPr>
          <a:xfrm>
            <a:off x="3048000" y="1636061"/>
            <a:ext cx="2326187" cy="293085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cs typeface="Arial" panose="020B0604020202020204" pitchFamily="34" charset="0"/>
              </a:rPr>
              <a:t>○ Mouse</a:t>
            </a:r>
            <a:r>
              <a:rPr lang="en-US" altLang="ko-KR" dirty="0"/>
              <a:t> </a:t>
            </a:r>
            <a:r>
              <a:rPr lang="en-US" altLang="ko-KR" i="1" dirty="0"/>
              <a:t>Albumin</a:t>
            </a:r>
            <a:r>
              <a:rPr lang="en-US" altLang="ko-KR" dirty="0"/>
              <a:t> </a:t>
            </a:r>
            <a:r>
              <a:rPr lang="en-US" altLang="ko-KR" sz="1800" dirty="0">
                <a:solidFill>
                  <a:srgbClr val="000000"/>
                </a:solidFill>
                <a:ea typeface="+mn-ea"/>
              </a:rPr>
              <a:t>chr11:83778144</a:t>
            </a:r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31331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1724499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000000"/>
                          </a:solidFill>
                          <a:ea typeface="+mn-ea"/>
                        </a:rPr>
                        <a:t>chr11:83778144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9.525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CAT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ATGTATGTGTG</a:t>
                      </a:r>
                      <a:r>
                        <a:rPr lang="en-US" altLang="ko-KR" sz="11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23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7669020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5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4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12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4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8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23090" y="134414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02366" y="133985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82B806A4-C123-4573-A854-2FD96ACA1E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0712142"/>
              </p:ext>
            </p:extLst>
          </p:nvPr>
        </p:nvGraphicFramePr>
        <p:xfrm>
          <a:off x="2865845" y="442005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CAT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ATGTATG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51474" y="1516066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613DD7B9-C21D-49DE-8864-D00C2836A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2243995"/>
              </p:ext>
            </p:extLst>
          </p:nvPr>
        </p:nvGraphicFramePr>
        <p:xfrm>
          <a:off x="143490" y="441685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CAT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ATGTATG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1991508" y="1513741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18435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4B81B7-226E-E918-3790-A67175F2A6AE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Human </a:t>
            </a:r>
            <a:r>
              <a:rPr lang="en-US" altLang="ko-KR" sz="3200" i="1" dirty="0"/>
              <a:t>VEGFA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122174989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VEGFA</a:t>
            </a:r>
            <a:r>
              <a:rPr lang="en-US" altLang="ko-KR" dirty="0"/>
              <a:t> chr1:33643288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:3364328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30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TG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GTTTGC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6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5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1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23460" y="136972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00198" y="1366350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6FB3847A-C7F1-4DAD-9D64-CECBF5041D2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0" t="17771" r="26505" b="12031"/>
          <a:stretch/>
        </p:blipFill>
        <p:spPr>
          <a:xfrm>
            <a:off x="2890916" y="1623172"/>
            <a:ext cx="2431582" cy="3004404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CC9B5FC-BBFA-46E6-97BF-D066890FDE74}"/>
              </a:ext>
            </a:extLst>
          </p:cNvPr>
          <p:cNvGraphicFramePr>
            <a:graphicFrameLocks noGrp="1"/>
          </p:cNvGraphicFramePr>
          <p:nvPr/>
        </p:nvGraphicFramePr>
        <p:xfrm>
          <a:off x="2798633" y="4510680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TGG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GTTT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11600" y="1530728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>
            <a:extLst>
              <a:ext uri="{FF2B5EF4-FFF2-40B4-BE49-F238E27FC236}">
                <a16:creationId xmlns:a16="http://schemas.microsoft.com/office/drawing/2014/main" id="{48A33B68-BF0D-4927-99A2-6060AF04E61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3" t="18054" r="26492" b="12055"/>
          <a:stretch/>
        </p:blipFill>
        <p:spPr>
          <a:xfrm>
            <a:off x="246516" y="1623172"/>
            <a:ext cx="2363359" cy="3004404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/>
        </p:nvGraphicFramePr>
        <p:xfrm>
          <a:off x="94657" y="450492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TGG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GTTTG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2008654" y="1497495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623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422885B-FD5D-44D1-BEE8-900005C22083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Human </a:t>
            </a:r>
            <a:r>
              <a:rPr lang="en-US" altLang="ko-KR" sz="3200" i="1" dirty="0"/>
              <a:t>PCSK9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16841764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VEGFA</a:t>
            </a:r>
            <a:r>
              <a:rPr lang="en-US" altLang="ko-KR" dirty="0"/>
              <a:t> chr3:128284321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3:128284321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14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A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45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45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9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253968" y="136569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44845" y="136569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9D4ECF3-12D0-4B14-AC08-0EB0ECD1FF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6" t="17707" r="26136" b="27216"/>
          <a:stretch/>
        </p:blipFill>
        <p:spPr>
          <a:xfrm>
            <a:off x="2942623" y="1615600"/>
            <a:ext cx="2380900" cy="3085795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400698CD-E4A4-477E-96D5-BD13A6058928}"/>
              </a:ext>
            </a:extLst>
          </p:cNvPr>
          <p:cNvGraphicFramePr>
            <a:graphicFrameLocks noGrp="1"/>
          </p:cNvGraphicFramePr>
          <p:nvPr/>
        </p:nvGraphicFramePr>
        <p:xfrm>
          <a:off x="2816144" y="4532892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55661" y="1504850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>
            <a:extLst>
              <a:ext uri="{FF2B5EF4-FFF2-40B4-BE49-F238E27FC236}">
                <a16:creationId xmlns:a16="http://schemas.microsoft.com/office/drawing/2014/main" id="{C171FC29-E976-49C8-A06C-205EC9B0AF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47" t="17717" r="25909" b="27392"/>
          <a:stretch/>
        </p:blipFill>
        <p:spPr>
          <a:xfrm>
            <a:off x="186135" y="1630013"/>
            <a:ext cx="2443059" cy="3085795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66A2A87F-FBBB-4C56-9677-E6BADABFDB95}"/>
              </a:ext>
            </a:extLst>
          </p:cNvPr>
          <p:cNvGraphicFramePr>
            <a:graphicFrameLocks noGrp="1"/>
          </p:cNvGraphicFramePr>
          <p:nvPr/>
        </p:nvGraphicFramePr>
        <p:xfrm>
          <a:off x="84233" y="456278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818211" y="1549251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852618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VEGFA</a:t>
            </a:r>
            <a:r>
              <a:rPr lang="en-US" altLang="ko-KR" dirty="0"/>
              <a:t> chr5:56172079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5:56172079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3.94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TTGCT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2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2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290454" y="1315541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44845" y="130646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 descr="테이블이(가) 표시된 사진&#10;&#10;자동 생성된 설명">
            <a:extLst>
              <a:ext uri="{FF2B5EF4-FFF2-40B4-BE49-F238E27FC236}">
                <a16:creationId xmlns:a16="http://schemas.microsoft.com/office/drawing/2014/main" id="{81A14822-0BA7-4D97-8AEF-BB825224D5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13" t="17703" r="26143" b="12795"/>
          <a:stretch/>
        </p:blipFill>
        <p:spPr>
          <a:xfrm>
            <a:off x="2982652" y="1608844"/>
            <a:ext cx="2408853" cy="3088256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03152175-2552-42D0-8127-927A33058D27}"/>
              </a:ext>
            </a:extLst>
          </p:cNvPr>
          <p:cNvGraphicFramePr>
            <a:graphicFrameLocks noGrp="1"/>
          </p:cNvGraphicFramePr>
          <p:nvPr/>
        </p:nvGraphicFramePr>
        <p:xfrm>
          <a:off x="2856941" y="4574857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CGTTT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98789" y="1504850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>
            <a:extLst>
              <a:ext uri="{FF2B5EF4-FFF2-40B4-BE49-F238E27FC236}">
                <a16:creationId xmlns:a16="http://schemas.microsoft.com/office/drawing/2014/main" id="{044FD0D9-E570-4C8E-A7D1-F82F1696B1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56" t="18302" r="26495" b="27339"/>
          <a:stretch/>
        </p:blipFill>
        <p:spPr>
          <a:xfrm>
            <a:off x="295667" y="1626096"/>
            <a:ext cx="2408853" cy="3088256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74DF5D9A-F1A0-4114-9BBF-41DD6D37D1C9}"/>
              </a:ext>
            </a:extLst>
          </p:cNvPr>
          <p:cNvGraphicFramePr>
            <a:graphicFrameLocks noGrp="1"/>
          </p:cNvGraphicFramePr>
          <p:nvPr/>
        </p:nvGraphicFramePr>
        <p:xfrm>
          <a:off x="180920" y="4561605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CGTTT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913101" y="1531999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1106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VEGFA</a:t>
            </a:r>
            <a:r>
              <a:rPr lang="en-US" altLang="ko-KR" dirty="0"/>
              <a:t> chr11:117481208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1:11748120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350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GA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CT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1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9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9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32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1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44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318669" y="1344162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64747" y="1358995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 descr="테이블이(가) 표시된 사진&#10;&#10;자동 생성된 설명">
            <a:extLst>
              <a:ext uri="{FF2B5EF4-FFF2-40B4-BE49-F238E27FC236}">
                <a16:creationId xmlns:a16="http://schemas.microsoft.com/office/drawing/2014/main" id="{60C03F6B-81A4-4137-B6AB-5C57289B15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75" t="17528" r="21623" b="27009"/>
          <a:stretch/>
        </p:blipFill>
        <p:spPr>
          <a:xfrm>
            <a:off x="2984728" y="1619266"/>
            <a:ext cx="2380900" cy="3081826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CA5E0FF5-C98B-4F33-9628-7B754E72BA4E}"/>
              </a:ext>
            </a:extLst>
          </p:cNvPr>
          <p:cNvGraphicFramePr>
            <a:graphicFrameLocks noGrp="1"/>
          </p:cNvGraphicFramePr>
          <p:nvPr/>
        </p:nvGraphicFramePr>
        <p:xfrm>
          <a:off x="2850648" y="4523285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CGT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a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98789" y="1513476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 descr="테이블이(가) 표시된 사진&#10;&#10;자동 생성된 설명">
            <a:extLst>
              <a:ext uri="{FF2B5EF4-FFF2-40B4-BE49-F238E27FC236}">
                <a16:creationId xmlns:a16="http://schemas.microsoft.com/office/drawing/2014/main" id="{438329F6-4C72-4A25-83A2-C9D8C585D7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75" t="17916" r="21604" b="27281"/>
          <a:stretch/>
        </p:blipFill>
        <p:spPr>
          <a:xfrm>
            <a:off x="263769" y="1619266"/>
            <a:ext cx="2448605" cy="3057828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5FC207A8-BABD-4F2A-8B90-82E4D93370E5}"/>
              </a:ext>
            </a:extLst>
          </p:cNvPr>
          <p:cNvGraphicFramePr>
            <a:graphicFrameLocks noGrp="1"/>
          </p:cNvGraphicFramePr>
          <p:nvPr/>
        </p:nvGraphicFramePr>
        <p:xfrm>
          <a:off x="167869" y="4510316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TCGT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GG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a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904475" y="1497495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0924827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4B81B7-226E-E918-3790-A67175F2A6AE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Human </a:t>
            </a:r>
            <a:r>
              <a:rPr lang="en-US" altLang="ko-KR" sz="3200" i="1" dirty="0"/>
              <a:t>FANCF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166133740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FANCF</a:t>
            </a:r>
            <a:r>
              <a:rPr lang="en-US" altLang="ko-KR" dirty="0"/>
              <a:t> chr6:143382079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6:143382079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98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GCA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>
                        <a:solidFill>
                          <a:srgbClr val="00B0F0"/>
                        </a:solidFill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8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8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16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303102" y="136782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45222" y="137497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9BF3DDBC-E53F-48C6-AE60-F543A76D5A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75" t="17466" r="21453" b="20590"/>
          <a:stretch/>
        </p:blipFill>
        <p:spPr>
          <a:xfrm>
            <a:off x="327804" y="1776734"/>
            <a:ext cx="2454821" cy="2752438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7E5FBB8D-1D39-4F74-B804-55BB461D2966}"/>
              </a:ext>
            </a:extLst>
          </p:cNvPr>
          <p:cNvGraphicFramePr>
            <a:graphicFrameLocks noGrp="1"/>
          </p:cNvGraphicFramePr>
          <p:nvPr/>
        </p:nvGraphicFramePr>
        <p:xfrm>
          <a:off x="209904" y="4417196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err="1">
                          <a:solidFill>
                            <a:srgbClr val="00B0F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ACGACG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ko-KR" altLang="en-US" sz="14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887224" y="1531999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그림 6">
            <a:extLst>
              <a:ext uri="{FF2B5EF4-FFF2-40B4-BE49-F238E27FC236}">
                <a16:creationId xmlns:a16="http://schemas.microsoft.com/office/drawing/2014/main" id="{0660BBBA-B449-4C61-A0A8-B947634BA9D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74" t="18027" r="21394" b="12196"/>
          <a:stretch/>
        </p:blipFill>
        <p:spPr>
          <a:xfrm>
            <a:off x="2978151" y="1611419"/>
            <a:ext cx="2429447" cy="3100422"/>
          </a:xfrm>
          <a:prstGeom prst="rect">
            <a:avLst/>
          </a:prstGeom>
        </p:spPr>
      </p:pic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78CC43A3-78E1-4BDF-BB13-FAC1EFD5A228}"/>
              </a:ext>
            </a:extLst>
          </p:cNvPr>
          <p:cNvGraphicFramePr>
            <a:graphicFrameLocks noGrp="1"/>
          </p:cNvGraphicFramePr>
          <p:nvPr/>
        </p:nvGraphicFramePr>
        <p:xfrm>
          <a:off x="2863158" y="4552842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err="1">
                          <a:solidFill>
                            <a:srgbClr val="00B0F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ACGACG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dirty="0" err="1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ko-KR" altLang="en-US" sz="14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98307" y="1469026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902289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FANCF</a:t>
            </a:r>
            <a:r>
              <a:rPr lang="en-US" altLang="ko-KR" dirty="0"/>
              <a:t> chr16:49671025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6:49671025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82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CC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AGCA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73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73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303102" y="136782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45222" y="137497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A74A430-18A9-45E1-BD57-6C2BD26969D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6" t="18090" r="28195" b="11724"/>
          <a:stretch/>
        </p:blipFill>
        <p:spPr>
          <a:xfrm>
            <a:off x="2968508" y="1609584"/>
            <a:ext cx="2380900" cy="3030122"/>
          </a:xfrm>
          <a:prstGeom prst="rect">
            <a:avLst/>
          </a:prstGeom>
        </p:spPr>
      </p:pic>
      <p:graphicFrame>
        <p:nvGraphicFramePr>
          <p:cNvPr id="19" name="표 18">
            <a:extLst>
              <a:ext uri="{FF2B5EF4-FFF2-40B4-BE49-F238E27FC236}">
                <a16:creationId xmlns:a16="http://schemas.microsoft.com/office/drawing/2014/main" id="{9A146049-43B9-49E7-886D-F83EA710C042}"/>
              </a:ext>
            </a:extLst>
          </p:cNvPr>
          <p:cNvGraphicFramePr>
            <a:graphicFrameLocks noGrp="1"/>
          </p:cNvGraphicFramePr>
          <p:nvPr/>
        </p:nvGraphicFramePr>
        <p:xfrm>
          <a:off x="2843717" y="453394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ACGACGTC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CCC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72907" y="1513476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 descr="테이블이(가) 표시된 사진&#10;&#10;자동 생성된 설명">
            <a:extLst>
              <a:ext uri="{FF2B5EF4-FFF2-40B4-BE49-F238E27FC236}">
                <a16:creationId xmlns:a16="http://schemas.microsoft.com/office/drawing/2014/main" id="{8B2E1D0F-C2E0-4F11-B551-452D910D273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55" t="17964" r="28714" b="27483"/>
          <a:stretch/>
        </p:blipFill>
        <p:spPr>
          <a:xfrm>
            <a:off x="263768" y="1618209"/>
            <a:ext cx="2397879" cy="3084884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0A812964-2CD9-40B2-90FB-78E59800505E}"/>
              </a:ext>
            </a:extLst>
          </p:cNvPr>
          <p:cNvGraphicFramePr>
            <a:graphicFrameLocks noGrp="1"/>
          </p:cNvGraphicFramePr>
          <p:nvPr/>
        </p:nvGraphicFramePr>
        <p:xfrm>
          <a:off x="146413" y="4545854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CACGACGTC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CCC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887224" y="1531999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057051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FANCF</a:t>
            </a:r>
            <a:r>
              <a:rPr lang="en-US" altLang="ko-KR" dirty="0"/>
              <a:t> chr17:78923978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7:7892397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3.09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C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TGCAGCA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1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5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2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1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12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503781" y="1335224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729957" y="133184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7A7E9D49-0B8A-47C1-9136-7187234D0B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36" t="18255" r="28907" b="13214"/>
          <a:stretch/>
        </p:blipFill>
        <p:spPr>
          <a:xfrm>
            <a:off x="2994388" y="1614201"/>
            <a:ext cx="2380899" cy="3018731"/>
          </a:xfrm>
          <a:prstGeom prst="rect">
            <a:avLst/>
          </a:prstGeom>
        </p:spPr>
      </p:pic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D177525C-C0C9-4DC6-8D2A-E9EB5247D18A}"/>
              </a:ext>
            </a:extLst>
          </p:cNvPr>
          <p:cNvGraphicFramePr>
            <a:graphicFrameLocks noGrp="1"/>
          </p:cNvGraphicFramePr>
          <p:nvPr/>
        </p:nvGraphicFramePr>
        <p:xfrm>
          <a:off x="2859016" y="4518875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C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TGCAGCA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71979" y="1504850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그림 6">
            <a:extLst>
              <a:ext uri="{FF2B5EF4-FFF2-40B4-BE49-F238E27FC236}">
                <a16:creationId xmlns:a16="http://schemas.microsoft.com/office/drawing/2014/main" id="{7D7AD3D1-AF0C-4738-81E1-E0CE399FC46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63" t="17438" r="28770" b="16167"/>
          <a:stretch/>
        </p:blipFill>
        <p:spPr>
          <a:xfrm>
            <a:off x="229036" y="1608844"/>
            <a:ext cx="2380900" cy="3018731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/>
        </p:nvGraphicFramePr>
        <p:xfrm>
          <a:off x="94657" y="451355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C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TGCAGCA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2000028" y="1506121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8078127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FANCF</a:t>
            </a:r>
            <a:r>
              <a:rPr lang="en-US" altLang="ko-KR" dirty="0"/>
              <a:t> chrX:86355180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/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X:86355180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35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CC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AGCA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2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4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4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44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5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01653" y="1337203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592156" y="1337204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4E3B6EC-8E1B-4705-91FE-67C701E1F02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9" t="17759" r="21678" b="14594"/>
          <a:stretch/>
        </p:blipFill>
        <p:spPr>
          <a:xfrm>
            <a:off x="2894766" y="1601719"/>
            <a:ext cx="2380898" cy="3005830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F5DEB604-12C0-4649-9E2E-8E0C65C43C20}"/>
              </a:ext>
            </a:extLst>
          </p:cNvPr>
          <p:cNvGraphicFramePr>
            <a:graphicFrameLocks noGrp="1"/>
          </p:cNvGraphicFramePr>
          <p:nvPr/>
        </p:nvGraphicFramePr>
        <p:xfrm>
          <a:off x="2760407" y="448733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C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AGCA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651214" y="1427216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그림 20" descr="테이블이(가) 표시된 사진&#10;&#10;자동 생성된 설명">
            <a:extLst>
              <a:ext uri="{FF2B5EF4-FFF2-40B4-BE49-F238E27FC236}">
                <a16:creationId xmlns:a16="http://schemas.microsoft.com/office/drawing/2014/main" id="{74C3F6AB-03B2-4B87-8512-D5D861A03F5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8" t="18037" r="21974" b="27216"/>
          <a:stretch/>
        </p:blipFill>
        <p:spPr>
          <a:xfrm>
            <a:off x="207860" y="1614201"/>
            <a:ext cx="2380898" cy="3018731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/>
        </p:nvGraphicFramePr>
        <p:xfrm>
          <a:off x="68779" y="4470419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CCT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AGCA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D876861F-333D-4D5E-AD45-23D1D3000F42}"/>
              </a:ext>
            </a:extLst>
          </p:cNvPr>
          <p:cNvCxnSpPr>
            <a:cxnSpLocks/>
          </p:cNvCxnSpPr>
          <p:nvPr/>
        </p:nvCxnSpPr>
        <p:spPr>
          <a:xfrm>
            <a:off x="1982776" y="1471617"/>
            <a:ext cx="0" cy="3355836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97108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PCSK9</a:t>
            </a:r>
            <a:r>
              <a:rPr lang="en-US" altLang="ko-KR" dirty="0"/>
              <a:t> chr5:148961402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9170832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5:148961402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696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1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7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7585511"/>
              </p:ext>
            </p:extLst>
          </p:nvPr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9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9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9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86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86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94110" y="1370022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684507" y="1374361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D8365782-76EC-40D7-8506-3D74D71AC4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84" t="18315" r="23371" b="11162"/>
          <a:stretch/>
        </p:blipFill>
        <p:spPr>
          <a:xfrm>
            <a:off x="2972030" y="1601719"/>
            <a:ext cx="2406713" cy="2938141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31D7D8F-4185-41DA-91A4-DD5A6C1F9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3435968"/>
              </p:ext>
            </p:extLst>
          </p:nvPr>
        </p:nvGraphicFramePr>
        <p:xfrm>
          <a:off x="2839059" y="445410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729570" y="151506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그림 5">
            <a:extLst>
              <a:ext uri="{FF2B5EF4-FFF2-40B4-BE49-F238E27FC236}">
                <a16:creationId xmlns:a16="http://schemas.microsoft.com/office/drawing/2014/main" id="{1F096032-471E-41F8-818D-6879783CAAE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33" t="17599" r="23834"/>
          <a:stretch/>
        </p:blipFill>
        <p:spPr>
          <a:xfrm>
            <a:off x="379138" y="1592238"/>
            <a:ext cx="2406713" cy="2938141"/>
          </a:xfrm>
          <a:prstGeom prst="rect">
            <a:avLst/>
          </a:prstGeom>
        </p:spPr>
      </p:pic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6275818"/>
              </p:ext>
            </p:extLst>
          </p:nvPr>
        </p:nvGraphicFramePr>
        <p:xfrm>
          <a:off x="240538" y="445332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TGGGAAACTGAGGC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</a:t>
                      </a:r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2148938" y="151474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6382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4B81B7-226E-E918-3790-A67175F2A6AE}"/>
              </a:ext>
            </a:extLst>
          </p:cNvPr>
          <p:cNvSpPr txBox="1"/>
          <p:nvPr/>
        </p:nvSpPr>
        <p:spPr>
          <a:xfrm>
            <a:off x="1004113" y="2890391"/>
            <a:ext cx="7311749" cy="10772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3200" dirty="0"/>
              <a:t>Manually validated Human </a:t>
            </a:r>
            <a:r>
              <a:rPr lang="en-US" altLang="ko-KR" sz="3200" i="1" dirty="0"/>
              <a:t>Albumin</a:t>
            </a:r>
            <a:r>
              <a:rPr lang="en-US" altLang="ko-KR" sz="3200" dirty="0"/>
              <a:t> off-target from </a:t>
            </a:r>
            <a:r>
              <a:rPr lang="en-US" altLang="ko-KR" sz="3200" dirty="0" err="1"/>
              <a:t>Extru</a:t>
            </a:r>
            <a:r>
              <a:rPr lang="en-US" altLang="ko-KR" sz="3200" dirty="0"/>
              <a:t>-seq WGS using IGV</a:t>
            </a:r>
          </a:p>
        </p:txBody>
      </p:sp>
    </p:spTree>
    <p:extLst>
      <p:ext uri="{BB962C8B-B14F-4D97-AF65-F5344CB8AC3E}">
        <p14:creationId xmlns:p14="http://schemas.microsoft.com/office/powerpoint/2010/main" val="3953746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ALB</a:t>
            </a:r>
            <a:r>
              <a:rPr lang="en-US" altLang="ko-KR" dirty="0"/>
              <a:t> chr1:25298885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1992344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:25298885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.954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GCATATGTATGTGTG</a:t>
                      </a:r>
                      <a:r>
                        <a:rPr lang="en-US" altLang="ko-KR" sz="11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aG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endParaRPr lang="en-US" altLang="ko-KR" sz="11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(NAG PAM)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2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74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1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63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4418581" y="1368627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4613671" y="136912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39B0BAB9-BEBB-4B97-8CDE-AFDE8BBEC4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87" t="18276" r="28446" b="10569"/>
          <a:stretch/>
        </p:blipFill>
        <p:spPr>
          <a:xfrm>
            <a:off x="2847740" y="1607338"/>
            <a:ext cx="2570081" cy="2948697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2C2F5FD6-2A1D-47BF-8899-58CDF29102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8028232"/>
              </p:ext>
            </p:extLst>
          </p:nvPr>
        </p:nvGraphicFramePr>
        <p:xfrm>
          <a:off x="2811499" y="446411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TGCATATGTATGTGTG</a:t>
                      </a:r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4668610" y="145542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그림 6">
            <a:extLst>
              <a:ext uri="{FF2B5EF4-FFF2-40B4-BE49-F238E27FC236}">
                <a16:creationId xmlns:a16="http://schemas.microsoft.com/office/drawing/2014/main" id="{2F085DF6-C2E5-482B-B887-0CD206E24B0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65" t="17625" r="28568" b="13153"/>
          <a:stretch/>
        </p:blipFill>
        <p:spPr>
          <a:xfrm>
            <a:off x="210429" y="1607338"/>
            <a:ext cx="2508418" cy="2948697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203DD895-0F0E-4767-8008-E68864E47C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7845232"/>
              </p:ext>
            </p:extLst>
          </p:nvPr>
        </p:nvGraphicFramePr>
        <p:xfrm>
          <a:off x="141146" y="444336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TGCATATGTATGTGTG</a:t>
                      </a:r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a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1996538" y="149352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42252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ALB</a:t>
            </a:r>
            <a:r>
              <a:rPr lang="en-US" altLang="ko-KR" dirty="0"/>
              <a:t> chr7:94058068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pic>
        <p:nvPicPr>
          <p:cNvPr id="27" name="그림 26" descr="테이블이(가) 표시된 사진&#10;&#10;자동 생성된 설명">
            <a:extLst>
              <a:ext uri="{FF2B5EF4-FFF2-40B4-BE49-F238E27FC236}">
                <a16:creationId xmlns:a16="http://schemas.microsoft.com/office/drawing/2014/main" id="{C5B8BEAF-CD9A-4942-9D05-B687D14D78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5" t="15143" r="16904" b="17210"/>
          <a:stretch/>
        </p:blipFill>
        <p:spPr>
          <a:xfrm>
            <a:off x="336442" y="1601719"/>
            <a:ext cx="2406713" cy="3005830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20280263-B0DA-47AF-8C50-D02605E7068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81" t="13535" r="17358" b="25665"/>
          <a:stretch/>
        </p:blipFill>
        <p:spPr>
          <a:xfrm>
            <a:off x="2984795" y="1592655"/>
            <a:ext cx="2406713" cy="3014894"/>
          </a:xfrm>
          <a:prstGeom prst="rect">
            <a:avLst/>
          </a:prstGeom>
        </p:spPr>
      </p:pic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7674840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7:9405806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.256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CATATG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5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7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1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111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graphicFrame>
        <p:nvGraphicFramePr>
          <p:cNvPr id="34" name="표 33">
            <a:extLst>
              <a:ext uri="{FF2B5EF4-FFF2-40B4-BE49-F238E27FC236}">
                <a16:creationId xmlns:a16="http://schemas.microsoft.com/office/drawing/2014/main" id="{F9918B8D-6E02-4AC1-98B7-2E39425BBB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841075"/>
              </p:ext>
            </p:extLst>
          </p:nvPr>
        </p:nvGraphicFramePr>
        <p:xfrm>
          <a:off x="2875477" y="4468192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TGTATACGT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6155315"/>
              </p:ext>
            </p:extLst>
          </p:nvPr>
        </p:nvGraphicFramePr>
        <p:xfrm>
          <a:off x="232918" y="4453323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TGTATACGTA</a:t>
                      </a:r>
                      <a:r>
                        <a:rPr lang="en-US" sz="14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967838" y="1593093"/>
            <a:ext cx="0" cy="300583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365925" y="143008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44204" y="142721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624670" y="148458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9240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D33180F-E2A2-4748-B16B-94907EF85BAE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ALB</a:t>
            </a:r>
            <a:r>
              <a:rPr lang="en-US" altLang="ko-KR" dirty="0"/>
              <a:t> chr9:101725360</a:t>
            </a:r>
            <a:endParaRPr lang="ko-KR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0968A8-8CCC-4139-BEC7-B73F1A91F24F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7FED487-56D0-4F02-B7DE-A851E45A0567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7" name="표 32">
            <a:extLst>
              <a:ext uri="{FF2B5EF4-FFF2-40B4-BE49-F238E27FC236}">
                <a16:creationId xmlns:a16="http://schemas.microsoft.com/office/drawing/2014/main" id="{E4975F8B-4138-4A4B-AF20-C49D07DCF0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8491774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9:101725360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125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GCATATG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GTG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7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8" name="표 33">
            <a:extLst>
              <a:ext uri="{FF2B5EF4-FFF2-40B4-BE49-F238E27FC236}">
                <a16:creationId xmlns:a16="http://schemas.microsoft.com/office/drawing/2014/main" id="{2507806E-DF5F-41F9-BB99-CAE352ED65C9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0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8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08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CC5BB53E-A8B4-4ECD-BFF2-F467106A2DDF}"/>
              </a:ext>
            </a:extLst>
          </p:cNvPr>
          <p:cNvSpPr txBox="1"/>
          <p:nvPr/>
        </p:nvSpPr>
        <p:spPr>
          <a:xfrm>
            <a:off x="4418581" y="1368627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36D4D3-0804-4F62-BEDF-EFFE6FBB3037}"/>
              </a:ext>
            </a:extLst>
          </p:cNvPr>
          <p:cNvSpPr txBox="1"/>
          <p:nvPr/>
        </p:nvSpPr>
        <p:spPr>
          <a:xfrm>
            <a:off x="4613671" y="136912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DF1C9A6E-6F3A-4559-A019-A2AAFDAC6E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32" t="25539" r="21663" b="7948"/>
          <a:stretch/>
        </p:blipFill>
        <p:spPr>
          <a:xfrm>
            <a:off x="272395" y="1730555"/>
            <a:ext cx="2339052" cy="2839043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C2EEC39B-E2C2-4D5A-A25B-96CB5AB38C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9472161"/>
              </p:ext>
            </p:extLst>
          </p:nvPr>
        </p:nvGraphicFramePr>
        <p:xfrm>
          <a:off x="194760" y="4443368"/>
          <a:ext cx="2496128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96128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GCATATG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720319E8-3905-4358-9A99-4F1A12B69B83}"/>
              </a:ext>
            </a:extLst>
          </p:cNvPr>
          <p:cNvCxnSpPr>
            <a:cxnSpLocks/>
          </p:cNvCxnSpPr>
          <p:nvPr/>
        </p:nvCxnSpPr>
        <p:spPr>
          <a:xfrm>
            <a:off x="1987912" y="149352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" name="그림 19">
            <a:extLst>
              <a:ext uri="{FF2B5EF4-FFF2-40B4-BE49-F238E27FC236}">
                <a16:creationId xmlns:a16="http://schemas.microsoft.com/office/drawing/2014/main" id="{D5D2BF1F-812F-4297-9A35-FE7968E00F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32" t="23626" r="21740" b="15726"/>
          <a:stretch/>
        </p:blipFill>
        <p:spPr>
          <a:xfrm>
            <a:off x="2938518" y="1842058"/>
            <a:ext cx="2316850" cy="2588736"/>
          </a:xfrm>
          <a:prstGeom prst="rect">
            <a:avLst/>
          </a:prstGeom>
        </p:spPr>
      </p:pic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3C946120-9EDB-46D5-A881-0966571E1A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2715340"/>
              </p:ext>
            </p:extLst>
          </p:nvPr>
        </p:nvGraphicFramePr>
        <p:xfrm>
          <a:off x="2859077" y="4313019"/>
          <a:ext cx="2496128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96128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ATGCATATG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GTG</a:t>
                      </a:r>
                      <a:r>
                        <a:rPr lang="en-US" altLang="ko-KR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G</a:t>
                      </a:r>
                      <a:endParaRPr lang="en-US" altLang="ko-KR" sz="14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48BD4862-AD71-472F-97C1-46184780D5FD}"/>
              </a:ext>
            </a:extLst>
          </p:cNvPr>
          <p:cNvCxnSpPr>
            <a:cxnSpLocks/>
          </p:cNvCxnSpPr>
          <p:nvPr/>
        </p:nvCxnSpPr>
        <p:spPr>
          <a:xfrm>
            <a:off x="4659984" y="145542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91480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ALB</a:t>
            </a:r>
            <a:r>
              <a:rPr lang="en-US" altLang="ko-KR" dirty="0"/>
              <a:t> chr11:47164807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3689405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1:47164807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163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CA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TGTGTG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10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7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-0.024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2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05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pic>
        <p:nvPicPr>
          <p:cNvPr id="3" name="그림 2">
            <a:extLst>
              <a:ext uri="{FF2B5EF4-FFF2-40B4-BE49-F238E27FC236}">
                <a16:creationId xmlns:a16="http://schemas.microsoft.com/office/drawing/2014/main" id="{83E8DF40-2232-4B83-9D0A-7982243B407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02" t="17633" r="24031" b="2318"/>
          <a:stretch/>
        </p:blipFill>
        <p:spPr>
          <a:xfrm>
            <a:off x="2919013" y="1601720"/>
            <a:ext cx="2406712" cy="2997203"/>
          </a:xfrm>
          <a:prstGeom prst="rect">
            <a:avLst/>
          </a:prstGeom>
        </p:spPr>
      </p:pic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FA7D9443-6C13-4943-864F-86F757B912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1020804"/>
              </p:ext>
            </p:extLst>
          </p:nvPr>
        </p:nvGraphicFramePr>
        <p:xfrm>
          <a:off x="2799335" y="443756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GTGTAT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TACGTA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221145" y="137674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59444" y="138149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40850" y="144780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그림 5">
            <a:extLst>
              <a:ext uri="{FF2B5EF4-FFF2-40B4-BE49-F238E27FC236}">
                <a16:creationId xmlns:a16="http://schemas.microsoft.com/office/drawing/2014/main" id="{CB3CD973-179C-4285-AA50-CD0F801191E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4" t="17944" r="24487" b="10114"/>
          <a:stretch/>
        </p:blipFill>
        <p:spPr>
          <a:xfrm>
            <a:off x="172977" y="1592098"/>
            <a:ext cx="2406712" cy="2948696"/>
          </a:xfrm>
          <a:prstGeom prst="rect">
            <a:avLst/>
          </a:prstGeom>
        </p:spPr>
      </p:pic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C6AF8C7-F048-4F3F-93DD-C8F622C863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9097700"/>
              </p:ext>
            </p:extLst>
          </p:nvPr>
        </p:nvGraphicFramePr>
        <p:xfrm>
          <a:off x="64360" y="4428116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GTGTATG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TACGTA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800198" y="144780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15774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Human </a:t>
            </a:r>
            <a:r>
              <a:rPr lang="en-US" altLang="ko-KR" i="1" dirty="0"/>
              <a:t>ALB</a:t>
            </a:r>
            <a:r>
              <a:rPr lang="en-US" altLang="ko-KR" dirty="0"/>
              <a:t> chr14:39526922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3290454" y="102926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594847" y="929972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0916844"/>
              </p:ext>
            </p:extLst>
          </p:nvPr>
        </p:nvGraphicFramePr>
        <p:xfrm>
          <a:off x="1320801" y="5170294"/>
          <a:ext cx="6668295" cy="77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73768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815668">
                  <a:extLst>
                    <a:ext uri="{9D8B030D-6E8A-4147-A177-3AD203B41FA5}">
                      <a16:colId xmlns:a16="http://schemas.microsoft.com/office/drawing/2014/main" val="4177434312"/>
                    </a:ext>
                  </a:extLst>
                </a:gridCol>
                <a:gridCol w="1186425">
                  <a:extLst>
                    <a:ext uri="{9D8B030D-6E8A-4147-A177-3AD203B41FA5}">
                      <a16:colId xmlns:a16="http://schemas.microsoft.com/office/drawing/2014/main" val="2945710107"/>
                    </a:ext>
                  </a:extLst>
                </a:gridCol>
                <a:gridCol w="2456271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936163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</a:tblGrid>
              <a:tr h="2530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reatmen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Average inde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25303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4:39526922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+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17.375%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CATAT</a:t>
                      </a:r>
                      <a:r>
                        <a:rPr lang="en-US" altLang="ko-KR" sz="11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ko-KR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ATGTGTG</a:t>
                      </a:r>
                      <a:r>
                        <a:rPr lang="en-US" altLang="ko-KR" sz="11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GG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  <a:tr h="253033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as9 (-)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08%</a:t>
                      </a:r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23694264"/>
                  </a:ext>
                </a:extLst>
              </a:tr>
            </a:tbl>
          </a:graphicData>
        </a:graphic>
      </p:graphicFrame>
      <p:graphicFrame>
        <p:nvGraphicFramePr>
          <p:cNvPr id="33" name="표 33">
            <a:extLst>
              <a:ext uri="{FF2B5EF4-FFF2-40B4-BE49-F238E27FC236}">
                <a16:creationId xmlns:a16="http://schemas.microsoft.com/office/drawing/2014/main" id="{32DC660E-B85E-4D49-976A-0CA93C18912D}"/>
              </a:ext>
            </a:extLst>
          </p:cNvPr>
          <p:cNvGraphicFramePr>
            <a:graphicFrameLocks noGrp="1"/>
          </p:cNvGraphicFramePr>
          <p:nvPr/>
        </p:nvGraphicFramePr>
        <p:xfrm>
          <a:off x="5510473" y="1872495"/>
          <a:ext cx="3476343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4867">
                  <a:extLst>
                    <a:ext uri="{9D8B030D-6E8A-4147-A177-3AD203B41FA5}">
                      <a16:colId xmlns:a16="http://schemas.microsoft.com/office/drawing/2014/main" val="664547976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133167532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56637729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2318380270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708438697"/>
                    </a:ext>
                  </a:extLst>
                </a:gridCol>
                <a:gridCol w="494867">
                  <a:extLst>
                    <a:ext uri="{9D8B030D-6E8A-4147-A177-3AD203B41FA5}">
                      <a16:colId xmlns:a16="http://schemas.microsoft.com/office/drawing/2014/main" val="1827527886"/>
                    </a:ext>
                  </a:extLst>
                </a:gridCol>
                <a:gridCol w="507141">
                  <a:extLst>
                    <a:ext uri="{9D8B030D-6E8A-4147-A177-3AD203B41FA5}">
                      <a16:colId xmlns:a16="http://schemas.microsoft.com/office/drawing/2014/main" val="29957102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/>
                        <a:t>Whole genome sequencing read depth</a:t>
                      </a:r>
                      <a:endParaRPr lang="ko-KR" altLang="en-US" sz="1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98629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position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3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-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+3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1839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R(Blue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8759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F(Red)</a:t>
                      </a:r>
                    </a:p>
                    <a:p>
                      <a:pPr algn="ctr" latinLnBrk="1"/>
                      <a:r>
                        <a:rPr lang="en-US" altLang="ko-KR" sz="700" dirty="0"/>
                        <a:t>Cut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6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1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91363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Depth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40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28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2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1</a:t>
                      </a:r>
                      <a:endParaRPr lang="ko-KR" altLang="en-US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/>
                        <a:t>32</a:t>
                      </a:r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63507134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chemeClr val="bg1"/>
                          </a:solidFill>
                        </a:rPr>
                        <a:t>Digenome</a:t>
                      </a:r>
                      <a:r>
                        <a:rPr lang="en-US" altLang="ko-KR" sz="1000" b="1" dirty="0">
                          <a:solidFill>
                            <a:schemeClr val="bg1"/>
                          </a:solidFill>
                        </a:rPr>
                        <a:t>-seq Score</a:t>
                      </a:r>
                      <a:endParaRPr lang="ko-KR" altLang="en-US" sz="1000" b="1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138657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Forward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033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649504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Reverse score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666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007408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err="1"/>
                        <a:t>Cleavagee</a:t>
                      </a:r>
                      <a:r>
                        <a:rPr lang="en-US" altLang="ko-KR" sz="900" dirty="0"/>
                        <a:t> Score (forward + reverse)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900" dirty="0"/>
                        <a:t>0.699</a:t>
                      </a:r>
                      <a:endParaRPr lang="ko-KR" altLang="en-US" sz="9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0981838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A2826D66-038F-4D9B-BD14-4AA1EB76E37E}"/>
              </a:ext>
            </a:extLst>
          </p:cNvPr>
          <p:cNvSpPr txBox="1"/>
          <p:nvPr/>
        </p:nvSpPr>
        <p:spPr>
          <a:xfrm>
            <a:off x="3221145" y="1376749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1</a:t>
            </a:r>
            <a:endParaRPr lang="ko-KR" alt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B9B3BA0-7A17-4593-BB34-1D23A3EF3444}"/>
              </a:ext>
            </a:extLst>
          </p:cNvPr>
          <p:cNvSpPr txBox="1"/>
          <p:nvPr/>
        </p:nvSpPr>
        <p:spPr>
          <a:xfrm>
            <a:off x="3559444" y="1381496"/>
            <a:ext cx="45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+1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1B718121-AF93-4999-BDC1-C9AB2E160C1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52" t="18300" r="23667" b="4614"/>
          <a:stretch/>
        </p:blipFill>
        <p:spPr>
          <a:xfrm>
            <a:off x="2919669" y="1599718"/>
            <a:ext cx="2406712" cy="2948696"/>
          </a:xfrm>
          <a:prstGeom prst="rect">
            <a:avLst/>
          </a:prstGeom>
        </p:spPr>
      </p:pic>
      <p:graphicFrame>
        <p:nvGraphicFramePr>
          <p:cNvPr id="19" name="표 18">
            <a:extLst>
              <a:ext uri="{FF2B5EF4-FFF2-40B4-BE49-F238E27FC236}">
                <a16:creationId xmlns:a16="http://schemas.microsoft.com/office/drawing/2014/main" id="{F847C4D0-DB94-4811-825D-AA8E5A08F2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0025432"/>
              </p:ext>
            </p:extLst>
          </p:nvPr>
        </p:nvGraphicFramePr>
        <p:xfrm>
          <a:off x="2793615" y="445479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GTGTA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ATACG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A</a:t>
                      </a:r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3533230" y="144780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그림 7" descr="테이블이(가) 표시된 사진&#10;&#10;자동 생성된 설명">
            <a:extLst>
              <a:ext uri="{FF2B5EF4-FFF2-40B4-BE49-F238E27FC236}">
                <a16:creationId xmlns:a16="http://schemas.microsoft.com/office/drawing/2014/main" id="{6C0ACB1B-F9D6-4AEE-8768-3BEA993AD60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10" t="17368" r="24207" b="5573"/>
          <a:stretch/>
        </p:blipFill>
        <p:spPr>
          <a:xfrm>
            <a:off x="301014" y="1599718"/>
            <a:ext cx="2406713" cy="2954996"/>
          </a:xfrm>
          <a:prstGeom prst="rect">
            <a:avLst/>
          </a:prstGeom>
        </p:spPr>
      </p:pic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203DD895-0F0E-4767-8008-E68864E47C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3405759"/>
              </p:ext>
            </p:extLst>
          </p:nvPr>
        </p:nvGraphicFramePr>
        <p:xfrm>
          <a:off x="186866" y="4466228"/>
          <a:ext cx="2653254" cy="2209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53254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G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TGTGTA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ATACGT</a:t>
                      </a:r>
                      <a:r>
                        <a:rPr lang="en-US" sz="1400" b="0" i="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CA</a:t>
                      </a:r>
                      <a:r>
                        <a:rPr lang="en-US" sz="1400" b="0" i="0" u="none" strike="noStrike" dirty="0" err="1">
                          <a:solidFill>
                            <a:srgbClr val="E9EBF5"/>
                          </a:solidFill>
                          <a:effectLst/>
                          <a:latin typeface="Courier New" panose="02070309020205020404" pitchFamily="49" charset="0"/>
                          <a:ea typeface="맑은 고딕" panose="020B0503020000020004" pitchFamily="50" charset="-127"/>
                          <a:cs typeface="Courier New" panose="02070309020205020404" pitchFamily="49" charset="0"/>
                        </a:rPr>
                        <a:t>g</a:t>
                      </a:r>
                      <a:endParaRPr lang="en-US" sz="1400" b="0" i="0" u="none" strike="noStrike" dirty="0">
                        <a:solidFill>
                          <a:srgbClr val="E9EBF5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929738" y="1493520"/>
            <a:ext cx="0" cy="3337560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4303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1</TotalTime>
  <Words>1980</Words>
  <Application>Microsoft Office PowerPoint</Application>
  <PresentationFormat>화면 슬라이드 쇼(4:3)</PresentationFormat>
  <Paragraphs>1169</Paragraphs>
  <Slides>2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7</vt:i4>
      </vt:variant>
    </vt:vector>
  </HeadingPairs>
  <TitlesOfParts>
    <vt:vector size="33" baseType="lpstr">
      <vt:lpstr>맑은 고딕</vt:lpstr>
      <vt:lpstr>Arial</vt:lpstr>
      <vt:lpstr>Calibri</vt:lpstr>
      <vt:lpstr>Calibri Light</vt:lpstr>
      <vt:lpstr>Courier New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won Jeonghun</dc:creator>
  <cp:lastModifiedBy>Lee Jungjoon</cp:lastModifiedBy>
  <cp:revision>28</cp:revision>
  <dcterms:created xsi:type="dcterms:W3CDTF">2021-11-29T01:57:27Z</dcterms:created>
  <dcterms:modified xsi:type="dcterms:W3CDTF">2022-12-14T10:10:59Z</dcterms:modified>
</cp:coreProperties>
</file>